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605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33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137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1200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015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227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0001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915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031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363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975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D57E4-593E-4BFA-AF75-8185F3DB5823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21983-1D0D-49B2-9588-A131DFFE5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619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グループ化 11"/>
          <p:cNvGrpSpPr/>
          <p:nvPr/>
        </p:nvGrpSpPr>
        <p:grpSpPr>
          <a:xfrm>
            <a:off x="360609" y="347729"/>
            <a:ext cx="11462196" cy="5360631"/>
            <a:chOff x="386367" y="566670"/>
            <a:chExt cx="11462196" cy="5360631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367" y="566670"/>
              <a:ext cx="11462196" cy="5360631"/>
            </a:xfrm>
            <a:prstGeom prst="rect">
              <a:avLst/>
            </a:prstGeom>
          </p:spPr>
        </p:pic>
        <p:sp>
          <p:nvSpPr>
            <p:cNvPr id="27" name="ドーナツ 26"/>
            <p:cNvSpPr/>
            <p:nvPr/>
          </p:nvSpPr>
          <p:spPr>
            <a:xfrm>
              <a:off x="6696635" y="600075"/>
              <a:ext cx="322351" cy="391598"/>
            </a:xfrm>
            <a:prstGeom prst="donut">
              <a:avLst/>
            </a:prstGeom>
            <a:solidFill>
              <a:schemeClr val="bg1"/>
            </a:solidFill>
            <a:ln w="285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  <p:sp>
        <p:nvSpPr>
          <p:cNvPr id="33" name="テキスト ボックス 32"/>
          <p:cNvSpPr txBox="1"/>
          <p:nvPr/>
        </p:nvSpPr>
        <p:spPr>
          <a:xfrm>
            <a:off x="6285437" y="4765182"/>
            <a:ext cx="35930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CRIs decrease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60608" y="4594852"/>
            <a:ext cx="41049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+ Iron Chelator</a:t>
            </a:r>
          </a:p>
          <a:p>
            <a:pPr algn="ctr"/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dditive effects of anti-microbial and anti-biofilm activity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80302" y="772732"/>
            <a:ext cx="53962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Minocycline</a:t>
            </a:r>
            <a:r>
              <a:rPr lang="ja-JP" altLang="en-US" sz="3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or Miconazole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8229757" y="3209805"/>
            <a:ext cx="35930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Rifampicin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360608" y="5997393"/>
            <a:ext cx="671633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othesized efficacy of antimicrobial- and iron-chelating agent-impregnated catheters. CRI: catheter-related infection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9440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3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　和広／Ito,Kazuhiro</dc:creator>
  <cp:lastModifiedBy>伊藤　和広／Ito,Kazuhiro</cp:lastModifiedBy>
  <cp:revision>5</cp:revision>
  <dcterms:created xsi:type="dcterms:W3CDTF">2022-06-17T03:37:31Z</dcterms:created>
  <dcterms:modified xsi:type="dcterms:W3CDTF">2023-05-26T03:59:52Z</dcterms:modified>
</cp:coreProperties>
</file>